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37A"/>
    <a:srgbClr val="004277"/>
    <a:srgbClr val="296DC0"/>
    <a:srgbClr val="AA0065"/>
    <a:srgbClr val="0092F7"/>
    <a:srgbClr val="65AA00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9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875898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linical course and management of children with IgA vasculitis with nephrit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6200" y="1166312"/>
            <a:ext cx="1188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with IgA vasculitis with nephritis are often managed conservatively and have an overall good prognosi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tone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241143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Kidney outcomes were favorable in a large cohort of children with IgA vasculitis with nephritis. Immunosuppressive medications were used in those with more severe presentation, though conservative management was used in the majority of case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2E340C23-EBDE-55B1-F7FE-26004F90DCD5}"/>
              </a:ext>
            </a:extLst>
          </p:cNvPr>
          <p:cNvGrpSpPr/>
          <p:nvPr/>
        </p:nvGrpSpPr>
        <p:grpSpPr>
          <a:xfrm>
            <a:off x="6717515" y="2131720"/>
            <a:ext cx="2132957" cy="3162441"/>
            <a:chOff x="5819256" y="2129646"/>
            <a:chExt cx="2132957" cy="3162441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56160225-B54A-40F5-B8BC-03D30EAFA84D}"/>
                </a:ext>
              </a:extLst>
            </p:cNvPr>
            <p:cNvSpPr/>
            <p:nvPr/>
          </p:nvSpPr>
          <p:spPr>
            <a:xfrm>
              <a:off x="5819256" y="2129646"/>
              <a:ext cx="2132957" cy="802453"/>
            </a:xfrm>
            <a:prstGeom prst="rect">
              <a:avLst/>
            </a:prstGeom>
            <a:solidFill>
              <a:srgbClr val="AA0065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56.8% managed with observation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4024351E-0010-D0B2-88B8-7CBD80D8E284}"/>
                </a:ext>
              </a:extLst>
            </p:cNvPr>
            <p:cNvSpPr/>
            <p:nvPr/>
          </p:nvSpPr>
          <p:spPr>
            <a:xfrm>
              <a:off x="5819256" y="3663452"/>
              <a:ext cx="2132957" cy="739885"/>
            </a:xfrm>
            <a:prstGeom prst="rect">
              <a:avLst/>
            </a:prstGeom>
            <a:solidFill>
              <a:srgbClr val="AA0065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36.3% systemic steroids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B352520D-1A70-9AEE-DED5-4E385D0BA1AE}"/>
                </a:ext>
              </a:extLst>
            </p:cNvPr>
            <p:cNvSpPr/>
            <p:nvPr/>
          </p:nvSpPr>
          <p:spPr>
            <a:xfrm>
              <a:off x="5840046" y="2939264"/>
              <a:ext cx="2091379" cy="724188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6.1% RAAS blockade alone</a:t>
              </a: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18F9284-DD09-8CA4-8EC8-133513686256}"/>
                </a:ext>
              </a:extLst>
            </p:cNvPr>
            <p:cNvSpPr/>
            <p:nvPr/>
          </p:nvSpPr>
          <p:spPr>
            <a:xfrm>
              <a:off x="5840046" y="4418027"/>
              <a:ext cx="2091379" cy="874060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7.9% immunosuppressive medications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FB7BEE45-4D50-AFDE-AFF6-0D0DBEE86596}"/>
              </a:ext>
            </a:extLst>
          </p:cNvPr>
          <p:cNvGrpSpPr/>
          <p:nvPr/>
        </p:nvGrpSpPr>
        <p:grpSpPr>
          <a:xfrm>
            <a:off x="3546491" y="2136427"/>
            <a:ext cx="1846586" cy="3227095"/>
            <a:chOff x="2998053" y="1883513"/>
            <a:chExt cx="1846586" cy="3227095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707FB10-61C6-B3FB-3640-7769B3343496}"/>
                </a:ext>
              </a:extLst>
            </p:cNvPr>
            <p:cNvSpPr/>
            <p:nvPr/>
          </p:nvSpPr>
          <p:spPr>
            <a:xfrm>
              <a:off x="2998053" y="4487767"/>
              <a:ext cx="1833210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274 seen by nephrology once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27EA956D-9AB8-9A8F-96A3-8A1B6CFECBE4}"/>
                </a:ext>
              </a:extLst>
            </p:cNvPr>
            <p:cNvSpPr/>
            <p:nvPr/>
          </p:nvSpPr>
          <p:spPr>
            <a:xfrm>
              <a:off x="3011429" y="1883513"/>
              <a:ext cx="1833210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5389 not seen by nephrology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281FD81-F876-CD70-3503-7E6EFB423729}"/>
                </a:ext>
              </a:extLst>
            </p:cNvPr>
            <p:cNvSpPr/>
            <p:nvPr/>
          </p:nvSpPr>
          <p:spPr>
            <a:xfrm>
              <a:off x="3011429" y="2666240"/>
              <a:ext cx="1819834" cy="1656907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bg1"/>
                  </a:solidFill>
                </a:rPr>
                <a:t>1139 followed by nephrology 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6B121DC8-1CC1-479C-4B95-423851F425DA}"/>
              </a:ext>
            </a:extLst>
          </p:cNvPr>
          <p:cNvSpPr txBox="1"/>
          <p:nvPr/>
        </p:nvSpPr>
        <p:spPr>
          <a:xfrm>
            <a:off x="6864042" y="1644895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Managemen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1DC3F6-35D4-14AC-9837-F909FE65F23D}"/>
              </a:ext>
            </a:extLst>
          </p:cNvPr>
          <p:cNvSpPr txBox="1"/>
          <p:nvPr/>
        </p:nvSpPr>
        <p:spPr>
          <a:xfrm>
            <a:off x="9791391" y="1664476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Outcomes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384FB50F-E8CE-5844-1991-E8FE4D4959A7}"/>
              </a:ext>
            </a:extLst>
          </p:cNvPr>
          <p:cNvGrpSpPr/>
          <p:nvPr/>
        </p:nvGrpSpPr>
        <p:grpSpPr>
          <a:xfrm>
            <a:off x="194503" y="2690347"/>
            <a:ext cx="3015826" cy="2774537"/>
            <a:chOff x="188472" y="2256857"/>
            <a:chExt cx="3015826" cy="277453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315F34D-3907-C011-6ADF-3525D2B94099}"/>
                </a:ext>
              </a:extLst>
            </p:cNvPr>
            <p:cNvSpPr txBox="1"/>
            <p:nvPr/>
          </p:nvSpPr>
          <p:spPr>
            <a:xfrm>
              <a:off x="188472" y="2256857"/>
              <a:ext cx="24464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 err="1">
                  <a:solidFill>
                    <a:srgbClr val="296DC0"/>
                  </a:solidFill>
                </a:rPr>
                <a:t>PEDSnet</a:t>
              </a:r>
              <a:r>
                <a:rPr lang="en-GB" sz="2000" dirty="0">
                  <a:solidFill>
                    <a:srgbClr val="296DC0"/>
                  </a:solidFill>
                </a:rPr>
                <a:t> databas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54A846E-072F-EE56-7483-713C94EF5783}"/>
                </a:ext>
              </a:extLst>
            </p:cNvPr>
            <p:cNvSpPr txBox="1"/>
            <p:nvPr/>
          </p:nvSpPr>
          <p:spPr>
            <a:xfrm>
              <a:off x="382907" y="4323508"/>
              <a:ext cx="2046012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296DC0"/>
                  </a:solidFill>
                </a:rPr>
                <a:t>6802 children with IgA vasculitis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8E60C9EF-FD30-5909-5E95-B8D72DB5DCF4}"/>
                </a:ext>
              </a:extLst>
            </p:cNvPr>
            <p:cNvCxnSpPr/>
            <p:nvPr/>
          </p:nvCxnSpPr>
          <p:spPr>
            <a:xfrm flipV="1">
              <a:off x="2488465" y="3390305"/>
              <a:ext cx="715833" cy="1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2ED5DC66-E528-C6D1-7DCF-82F41C08D182}"/>
                </a:ext>
              </a:extLst>
            </p:cNvPr>
            <p:cNvCxnSpPr>
              <a:cxnSpLocks/>
            </p:cNvCxnSpPr>
            <p:nvPr/>
          </p:nvCxnSpPr>
          <p:spPr>
            <a:xfrm>
              <a:off x="2503001" y="3602205"/>
              <a:ext cx="675415" cy="821956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7C7290EF-6D44-2491-9D54-FAC493FC364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03001" y="2377324"/>
              <a:ext cx="636516" cy="818097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39DDF03-F0D9-45A6-5649-37272A98291F}"/>
                </a:ext>
              </a:extLst>
            </p:cNvPr>
            <p:cNvGrpSpPr/>
            <p:nvPr/>
          </p:nvGrpSpPr>
          <p:grpSpPr>
            <a:xfrm>
              <a:off x="513466" y="2633566"/>
              <a:ext cx="1695776" cy="1585546"/>
              <a:chOff x="485956" y="2598200"/>
              <a:chExt cx="1695776" cy="1585546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538CE547-708D-20CD-5781-9FFDC7432015}"/>
                  </a:ext>
                </a:extLst>
              </p:cNvPr>
              <p:cNvGrpSpPr/>
              <p:nvPr/>
            </p:nvGrpSpPr>
            <p:grpSpPr>
              <a:xfrm>
                <a:off x="742598" y="2598200"/>
                <a:ext cx="1439134" cy="1191990"/>
                <a:chOff x="255976" y="2945159"/>
                <a:chExt cx="1439134" cy="1191990"/>
              </a:xfrm>
            </p:grpSpPr>
            <p:sp>
              <p:nvSpPr>
                <p:cNvPr id="2" name="Freeform: Shape 46">
                  <a:extLst>
                    <a:ext uri="{FF2B5EF4-FFF2-40B4-BE49-F238E27FC236}">
                      <a16:creationId xmlns:a16="http://schemas.microsoft.com/office/drawing/2014/main" id="{CAC22A3C-45D4-225E-0478-2EC001353424}"/>
                    </a:ext>
                  </a:extLst>
                </p:cNvPr>
                <p:cNvSpPr/>
                <p:nvPr/>
              </p:nvSpPr>
              <p:spPr>
                <a:xfrm>
                  <a:off x="255976" y="2990816"/>
                  <a:ext cx="513284" cy="1049898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296DC0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/>
                </a:p>
              </p:txBody>
            </p:sp>
            <p:sp>
              <p:nvSpPr>
                <p:cNvPr id="3" name="Freeform: Shape 46">
                  <a:extLst>
                    <a:ext uri="{FF2B5EF4-FFF2-40B4-BE49-F238E27FC236}">
                      <a16:creationId xmlns:a16="http://schemas.microsoft.com/office/drawing/2014/main" id="{11979F40-6035-C0BA-0DD9-86A8B5D63FD1}"/>
                    </a:ext>
                  </a:extLst>
                </p:cNvPr>
                <p:cNvSpPr/>
                <p:nvPr/>
              </p:nvSpPr>
              <p:spPr>
                <a:xfrm>
                  <a:off x="1181826" y="3087251"/>
                  <a:ext cx="513284" cy="1049898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00437A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/>
                </a:p>
              </p:txBody>
            </p:sp>
            <p:sp>
              <p:nvSpPr>
                <p:cNvPr id="5" name="Freeform: Shape 46">
                  <a:extLst>
                    <a:ext uri="{FF2B5EF4-FFF2-40B4-BE49-F238E27FC236}">
                      <a16:creationId xmlns:a16="http://schemas.microsoft.com/office/drawing/2014/main" id="{FF0093D6-D395-89E9-9F72-562BAC0CF6B3}"/>
                    </a:ext>
                  </a:extLst>
                </p:cNvPr>
                <p:cNvSpPr/>
                <p:nvPr/>
              </p:nvSpPr>
              <p:spPr>
                <a:xfrm>
                  <a:off x="807294" y="2945159"/>
                  <a:ext cx="513284" cy="1049898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AA0065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2" name="Freeform: Shape 46">
                <a:extLst>
                  <a:ext uri="{FF2B5EF4-FFF2-40B4-BE49-F238E27FC236}">
                    <a16:creationId xmlns:a16="http://schemas.microsoft.com/office/drawing/2014/main" id="{0D347126-BA26-A7B0-B770-316E5D67DB25}"/>
                  </a:ext>
                </a:extLst>
              </p:cNvPr>
              <p:cNvSpPr/>
              <p:nvPr/>
            </p:nvSpPr>
            <p:spPr>
              <a:xfrm>
                <a:off x="1052383" y="3004678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3" name="Freeform: Shape 46">
                <a:extLst>
                  <a:ext uri="{FF2B5EF4-FFF2-40B4-BE49-F238E27FC236}">
                    <a16:creationId xmlns:a16="http://schemas.microsoft.com/office/drawing/2014/main" id="{FC780290-8E7B-2ECC-C4E1-8B12932186AE}"/>
                  </a:ext>
                </a:extLst>
              </p:cNvPr>
              <p:cNvSpPr/>
              <p:nvPr/>
            </p:nvSpPr>
            <p:spPr>
              <a:xfrm>
                <a:off x="485956" y="2960013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8" name="Freeform: Shape 46">
                <a:extLst>
                  <a:ext uri="{FF2B5EF4-FFF2-40B4-BE49-F238E27FC236}">
                    <a16:creationId xmlns:a16="http://schemas.microsoft.com/office/drawing/2014/main" id="{49B13912-51F9-40CD-D879-B767A5A46A28}"/>
                  </a:ext>
                </a:extLst>
              </p:cNvPr>
              <p:cNvSpPr/>
              <p:nvPr/>
            </p:nvSpPr>
            <p:spPr>
              <a:xfrm>
                <a:off x="804624" y="3100545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9" name="Freeform: Shape 46">
                <a:extLst>
                  <a:ext uri="{FF2B5EF4-FFF2-40B4-BE49-F238E27FC236}">
                    <a16:creationId xmlns:a16="http://schemas.microsoft.com/office/drawing/2014/main" id="{7995CE6B-F38D-F4E3-6515-9F9AF54363D0}"/>
                  </a:ext>
                </a:extLst>
              </p:cNvPr>
              <p:cNvSpPr/>
              <p:nvPr/>
            </p:nvSpPr>
            <p:spPr>
              <a:xfrm>
                <a:off x="1420774" y="3133848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</p:grp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5128C3E4-FFAC-1DD9-ACAF-A2EB4DD561A5}"/>
              </a:ext>
            </a:extLst>
          </p:cNvPr>
          <p:cNvGrpSpPr/>
          <p:nvPr/>
        </p:nvGrpSpPr>
        <p:grpSpPr>
          <a:xfrm>
            <a:off x="9801807" y="2959123"/>
            <a:ext cx="1788806" cy="2335440"/>
            <a:chOff x="9310657" y="3009485"/>
            <a:chExt cx="1788806" cy="2335440"/>
          </a:xfrm>
        </p:grpSpPr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36C7A161-F9FF-37F7-19DC-903A656CDDF0}"/>
                </a:ext>
              </a:extLst>
            </p:cNvPr>
            <p:cNvSpPr/>
            <p:nvPr/>
          </p:nvSpPr>
          <p:spPr>
            <a:xfrm>
              <a:off x="9320835" y="4852638"/>
              <a:ext cx="1778628" cy="492287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bg1"/>
                  </a:solidFill>
                </a:rPr>
                <a:t>0.5% with kidney failure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7C47CEEC-D898-6493-4208-6282AC60A1E2}"/>
                </a:ext>
              </a:extLst>
            </p:cNvPr>
            <p:cNvSpPr/>
            <p:nvPr/>
          </p:nvSpPr>
          <p:spPr>
            <a:xfrm>
              <a:off x="9320835" y="4239075"/>
              <a:ext cx="1778628" cy="492287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bg1"/>
                  </a:solidFill>
                </a:rPr>
                <a:t>2.6% with </a:t>
              </a:r>
            </a:p>
            <a:p>
              <a:pPr algn="ctr"/>
              <a:r>
                <a:rPr lang="en-GB" dirty="0">
                  <a:solidFill>
                    <a:schemeClr val="bg1"/>
                  </a:solidFill>
                </a:rPr>
                <a:t>CKD 3-5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4C51249B-CBB9-B278-3F6F-971A0F44CBEE}"/>
                </a:ext>
              </a:extLst>
            </p:cNvPr>
            <p:cNvSpPr/>
            <p:nvPr/>
          </p:nvSpPr>
          <p:spPr>
            <a:xfrm>
              <a:off x="9320835" y="3624280"/>
              <a:ext cx="1778628" cy="493519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bg1"/>
                  </a:solidFill>
                </a:rPr>
                <a:t>2.5% treated for hypertension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CBCE2F37-2932-5286-0775-04C711B0E9A6}"/>
                </a:ext>
              </a:extLst>
            </p:cNvPr>
            <p:cNvSpPr/>
            <p:nvPr/>
          </p:nvSpPr>
          <p:spPr>
            <a:xfrm>
              <a:off x="9310657" y="3009485"/>
              <a:ext cx="1778628" cy="493519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bg1"/>
                  </a:solidFill>
                </a:rPr>
                <a:t>17.7% with proteinuria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697768A1-B33C-E6D8-861D-CB91BDC792F8}"/>
              </a:ext>
            </a:extLst>
          </p:cNvPr>
          <p:cNvSpPr txBox="1"/>
          <p:nvPr/>
        </p:nvSpPr>
        <p:spPr>
          <a:xfrm>
            <a:off x="9431245" y="2145540"/>
            <a:ext cx="25314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At the time of last follow-up:</a:t>
            </a:r>
          </a:p>
        </p:txBody>
      </p:sp>
      <p:grpSp>
        <p:nvGrpSpPr>
          <p:cNvPr id="1029" name="Group 1028">
            <a:extLst>
              <a:ext uri="{FF2B5EF4-FFF2-40B4-BE49-F238E27FC236}">
                <a16:creationId xmlns:a16="http://schemas.microsoft.com/office/drawing/2014/main" id="{72B92583-FAA3-A158-4FFD-F161DC668699}"/>
              </a:ext>
            </a:extLst>
          </p:cNvPr>
          <p:cNvGrpSpPr/>
          <p:nvPr/>
        </p:nvGrpSpPr>
        <p:grpSpPr>
          <a:xfrm>
            <a:off x="5498592" y="2629246"/>
            <a:ext cx="1081657" cy="2382058"/>
            <a:chOff x="5000018" y="2518312"/>
            <a:chExt cx="1081657" cy="2382058"/>
          </a:xfrm>
        </p:grpSpPr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C1628E5C-9ADB-8B8F-EEFA-F5EB53A18F94}"/>
                </a:ext>
              </a:extLst>
            </p:cNvPr>
            <p:cNvCxnSpPr>
              <a:cxnSpLocks/>
            </p:cNvCxnSpPr>
            <p:nvPr/>
          </p:nvCxnSpPr>
          <p:spPr>
            <a:xfrm>
              <a:off x="5752140" y="2532946"/>
              <a:ext cx="310520" cy="0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619F4B6A-F079-9287-E367-23C35D213E35}"/>
                </a:ext>
              </a:extLst>
            </p:cNvPr>
            <p:cNvCxnSpPr>
              <a:cxnSpLocks/>
            </p:cNvCxnSpPr>
            <p:nvPr/>
          </p:nvCxnSpPr>
          <p:spPr>
            <a:xfrm>
              <a:off x="5752140" y="3205480"/>
              <a:ext cx="310520" cy="0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551B56CB-6B5C-C445-A8A9-45A6B4E21ED2}"/>
                </a:ext>
              </a:extLst>
            </p:cNvPr>
            <p:cNvCxnSpPr>
              <a:cxnSpLocks/>
            </p:cNvCxnSpPr>
            <p:nvPr/>
          </p:nvCxnSpPr>
          <p:spPr>
            <a:xfrm>
              <a:off x="5771155" y="4010939"/>
              <a:ext cx="310520" cy="0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E2CEC1B8-1A90-9BB3-F7FA-F13AA7B1C3EA}"/>
                </a:ext>
              </a:extLst>
            </p:cNvPr>
            <p:cNvCxnSpPr>
              <a:cxnSpLocks/>
            </p:cNvCxnSpPr>
            <p:nvPr/>
          </p:nvCxnSpPr>
          <p:spPr>
            <a:xfrm>
              <a:off x="5752140" y="4900370"/>
              <a:ext cx="310520" cy="0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388A2F80-050F-FBAC-4CA6-F8226A12F8D9}"/>
                </a:ext>
              </a:extLst>
            </p:cNvPr>
            <p:cNvCxnSpPr/>
            <p:nvPr/>
          </p:nvCxnSpPr>
          <p:spPr>
            <a:xfrm>
              <a:off x="5752140" y="2518312"/>
              <a:ext cx="0" cy="2382058"/>
            </a:xfrm>
            <a:prstGeom prst="line">
              <a:avLst/>
            </a:prstGeom>
            <a:ln w="31750">
              <a:solidFill>
                <a:srgbClr val="00437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4" name="Straight Connector 1023">
              <a:extLst>
                <a:ext uri="{FF2B5EF4-FFF2-40B4-BE49-F238E27FC236}">
                  <a16:creationId xmlns:a16="http://schemas.microsoft.com/office/drawing/2014/main" id="{7899866C-F7E8-651D-71BD-12A254BEA48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00018" y="3603687"/>
              <a:ext cx="771137" cy="0"/>
            </a:xfrm>
            <a:prstGeom prst="line">
              <a:avLst/>
            </a:prstGeom>
            <a:ln w="31750">
              <a:solidFill>
                <a:srgbClr val="00437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59</TotalTime>
  <Words>145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3-05-09T14:26:26Z</dcterms:modified>
</cp:coreProperties>
</file>